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41DFE1C-EB1E-4929-99C6-1EF2EC649424}" v="6" dt="2021-06-02T17:46:07.99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199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Erpel" userId="29d1baa5783f2a02" providerId="LiveId" clId="{ED3F7DBC-9630-4F06-B960-A70A45474C87}"/>
    <pc:docChg chg="undo custSel modSld">
      <pc:chgData name="Fernanda Erpel" userId="29d1baa5783f2a02" providerId="LiveId" clId="{ED3F7DBC-9630-4F06-B960-A70A45474C87}" dt="2021-02-23T21:21:29.796" v="13" actId="1076"/>
      <pc:docMkLst>
        <pc:docMk/>
      </pc:docMkLst>
      <pc:sldChg chg="modSp mod">
        <pc:chgData name="Fernanda Erpel" userId="29d1baa5783f2a02" providerId="LiveId" clId="{ED3F7DBC-9630-4F06-B960-A70A45474C87}" dt="2021-02-23T21:21:29.796" v="13" actId="1076"/>
        <pc:sldMkLst>
          <pc:docMk/>
          <pc:sldMk cId="1410122683" sldId="256"/>
        </pc:sldMkLst>
        <pc:spChg chg="mod">
          <ac:chgData name="Fernanda Erpel" userId="29d1baa5783f2a02" providerId="LiveId" clId="{ED3F7DBC-9630-4F06-B960-A70A45474C87}" dt="2021-01-21T17:10:05.815" v="8"/>
          <ac:spMkLst>
            <pc:docMk/>
            <pc:sldMk cId="1410122683" sldId="256"/>
            <ac:spMk id="5" creationId="{7C3F3686-FE3A-437E-A48B-2E1356E4ADAC}"/>
          </ac:spMkLst>
        </pc:spChg>
        <pc:graphicFrameChg chg="mod">
          <ac:chgData name="Fernanda Erpel" userId="29d1baa5783f2a02" providerId="LiveId" clId="{ED3F7DBC-9630-4F06-B960-A70A45474C87}" dt="2021-02-23T21:21:29.796" v="13" actId="1076"/>
          <ac:graphicFrameMkLst>
            <pc:docMk/>
            <pc:sldMk cId="1410122683" sldId="256"/>
            <ac:graphicFrameMk id="2" creationId="{52175ED7-E29C-4E8A-8A80-BF7E1194163E}"/>
          </ac:graphicFrameMkLst>
        </pc:graphicFrameChg>
      </pc:sldChg>
    </pc:docChg>
  </pc:docChgLst>
  <pc:docChgLst>
    <pc:chgData name="Fernanda Erpel" userId="29d1baa5783f2a02" providerId="LiveId" clId="{241DFE1C-EB1E-4929-99C6-1EF2EC649424}"/>
    <pc:docChg chg="modSld">
      <pc:chgData name="Fernanda Erpel" userId="29d1baa5783f2a02" providerId="LiveId" clId="{241DFE1C-EB1E-4929-99C6-1EF2EC649424}" dt="2021-06-02T17:46:05.184" v="22" actId="1076"/>
      <pc:docMkLst>
        <pc:docMk/>
      </pc:docMkLst>
      <pc:sldChg chg="modSp mod">
        <pc:chgData name="Fernanda Erpel" userId="29d1baa5783f2a02" providerId="LiveId" clId="{241DFE1C-EB1E-4929-99C6-1EF2EC649424}" dt="2021-06-02T17:46:05.184" v="22" actId="1076"/>
        <pc:sldMkLst>
          <pc:docMk/>
          <pc:sldMk cId="1410122683" sldId="256"/>
        </pc:sldMkLst>
        <pc:spChg chg="mod">
          <ac:chgData name="Fernanda Erpel" userId="29d1baa5783f2a02" providerId="LiveId" clId="{241DFE1C-EB1E-4929-99C6-1EF2EC649424}" dt="2021-06-02T17:45:39.219" v="20" actId="2711"/>
          <ac:spMkLst>
            <pc:docMk/>
            <pc:sldMk cId="1410122683" sldId="256"/>
            <ac:spMk id="5" creationId="{7C3F3686-FE3A-437E-A48B-2E1356E4ADAC}"/>
          </ac:spMkLst>
        </pc:spChg>
        <pc:graphicFrameChg chg="mod">
          <ac:chgData name="Fernanda Erpel" userId="29d1baa5783f2a02" providerId="LiveId" clId="{241DFE1C-EB1E-4929-99C6-1EF2EC649424}" dt="2021-06-02T17:46:05.184" v="22" actId="1076"/>
          <ac:graphicFrameMkLst>
            <pc:docMk/>
            <pc:sldMk cId="1410122683" sldId="256"/>
            <ac:graphicFrameMk id="2" creationId="{52175ED7-E29C-4E8A-8A80-BF7E1194163E}"/>
          </ac:graphicFrameMkLst>
        </pc:graphicFrameChg>
      </pc:sldChg>
    </pc:docChg>
  </pc:docChgLst>
  <pc:docChgLst>
    <pc:chgData name="Fernanda Erpel" userId="29d1baa5783f2a02" providerId="LiveId" clId="{73B6070E-2E26-4E79-A54B-3B93F248AF15}"/>
    <pc:docChg chg="modSld">
      <pc:chgData name="Fernanda Erpel" userId="29d1baa5783f2a02" providerId="LiveId" clId="{73B6070E-2E26-4E79-A54B-3B93F248AF15}" dt="2020-12-16T15:05:15.612" v="3"/>
      <pc:docMkLst>
        <pc:docMk/>
      </pc:docMkLst>
      <pc:sldChg chg="modSp">
        <pc:chgData name="Fernanda Erpel" userId="29d1baa5783f2a02" providerId="LiveId" clId="{73B6070E-2E26-4E79-A54B-3B93F248AF15}" dt="2020-12-16T15:05:15.612" v="3"/>
        <pc:sldMkLst>
          <pc:docMk/>
          <pc:sldMk cId="1410122683" sldId="256"/>
        </pc:sldMkLst>
        <pc:graphicFrameChg chg="mod">
          <ac:chgData name="Fernanda Erpel" userId="29d1baa5783f2a02" providerId="LiveId" clId="{73B6070E-2E26-4E79-A54B-3B93F248AF15}" dt="2020-12-16T15:05:15.612" v="3"/>
          <ac:graphicFrameMkLst>
            <pc:docMk/>
            <pc:sldMk cId="1410122683" sldId="256"/>
            <ac:graphicFrameMk id="2" creationId="{52175ED7-E29C-4E8A-8A80-BF7E1194163E}"/>
          </ac:graphicFrameMkLst>
        </pc:graphicFrameChg>
      </pc:sldChg>
    </pc:docChg>
  </pc:docChgLst>
  <pc:docChgLst>
    <pc:chgData name="Fernanda Erpel" userId="29d1baa5783f2a02" providerId="LiveId" clId="{39E64E71-E9DD-4909-80B5-11DAF34EB040}"/>
    <pc:docChg chg="undo redo custSel modSld">
      <pc:chgData name="Fernanda Erpel" userId="29d1baa5783f2a02" providerId="LiveId" clId="{39E64E71-E9DD-4909-80B5-11DAF34EB040}" dt="2020-08-06T14:50:21.928" v="46" actId="20577"/>
      <pc:docMkLst>
        <pc:docMk/>
      </pc:docMkLst>
      <pc:sldChg chg="addSp delSp modSp">
        <pc:chgData name="Fernanda Erpel" userId="29d1baa5783f2a02" providerId="LiveId" clId="{39E64E71-E9DD-4909-80B5-11DAF34EB040}" dt="2020-08-06T14:50:21.928" v="46" actId="20577"/>
        <pc:sldMkLst>
          <pc:docMk/>
          <pc:sldMk cId="1410122683" sldId="256"/>
        </pc:sldMkLst>
        <pc:spChg chg="mod">
          <ac:chgData name="Fernanda Erpel" userId="29d1baa5783f2a02" providerId="LiveId" clId="{39E64E71-E9DD-4909-80B5-11DAF34EB040}" dt="2020-08-06T14:50:21.928" v="46" actId="20577"/>
          <ac:spMkLst>
            <pc:docMk/>
            <pc:sldMk cId="1410122683" sldId="256"/>
            <ac:spMk id="5" creationId="{7C3F3686-FE3A-437E-A48B-2E1356E4ADAC}"/>
          </ac:spMkLst>
        </pc:spChg>
        <pc:graphicFrameChg chg="add mod">
          <ac:chgData name="Fernanda Erpel" userId="29d1baa5783f2a02" providerId="LiveId" clId="{39E64E71-E9DD-4909-80B5-11DAF34EB040}" dt="2020-08-06T01:10:31.018" v="35"/>
          <ac:graphicFrameMkLst>
            <pc:docMk/>
            <pc:sldMk cId="1410122683" sldId="256"/>
            <ac:graphicFrameMk id="2" creationId="{52175ED7-E29C-4E8A-8A80-BF7E1194163E}"/>
          </ac:graphicFrameMkLst>
        </pc:graphicFrameChg>
        <pc:graphicFrameChg chg="add del mod">
          <ac:chgData name="Fernanda Erpel" userId="29d1baa5783f2a02" providerId="LiveId" clId="{39E64E71-E9DD-4909-80B5-11DAF34EB040}" dt="2020-08-06T01:05:10.445" v="31" actId="478"/>
          <ac:graphicFrameMkLst>
            <pc:docMk/>
            <pc:sldMk cId="1410122683" sldId="256"/>
            <ac:graphicFrameMk id="3" creationId="{403C2CE0-D340-4AB9-A0B3-FD6740990346}"/>
          </ac:graphicFrameMkLst>
        </pc:graphicFrameChg>
        <pc:graphicFrameChg chg="add del mod">
          <ac:chgData name="Fernanda Erpel" userId="29d1baa5783f2a02" providerId="LiveId" clId="{39E64E71-E9DD-4909-80B5-11DAF34EB040}" dt="2020-08-06T00:53:55.934" v="14" actId="478"/>
          <ac:graphicFrameMkLst>
            <pc:docMk/>
            <pc:sldMk cId="1410122683" sldId="256"/>
            <ac:graphicFrameMk id="6" creationId="{FAB28D54-55D1-4401-AEF0-0E622A9191B4}"/>
          </ac:graphicFrameMkLst>
        </pc:graphicFrameChg>
        <pc:graphicFrameChg chg="add del mod">
          <ac:chgData name="Fernanda Erpel" userId="29d1baa5783f2a02" providerId="LiveId" clId="{39E64E71-E9DD-4909-80B5-11DAF34EB040}" dt="2020-08-06T00:55:45.367" v="26" actId="478"/>
          <ac:graphicFrameMkLst>
            <pc:docMk/>
            <pc:sldMk cId="1410122683" sldId="256"/>
            <ac:graphicFrameMk id="7" creationId="{00145C95-32CB-47E5-A316-CA3F34183C41}"/>
          </ac:graphicFrameMkLst>
        </pc:graphicFrameChg>
        <pc:picChg chg="add del">
          <ac:chgData name="Fernanda Erpel" userId="29d1baa5783f2a02" providerId="LiveId" clId="{39E64E71-E9DD-4909-80B5-11DAF34EB040}" dt="2020-08-06T00:56:00.918" v="28"/>
          <ac:picMkLst>
            <pc:docMk/>
            <pc:sldMk cId="1410122683" sldId="256"/>
            <ac:picMk id="2" creationId="{E0032464-BF5F-4A5F-B479-C1B3C94EB911}"/>
          </ac:picMkLst>
        </pc:picChg>
      </pc:sldChg>
    </pc:docChg>
  </pc:docChgLst>
  <pc:docChgLst>
    <pc:chgData name="Fernanda Erpel" userId="29d1baa5783f2a02" providerId="LiveId" clId="{5888FCE2-01D7-435A-81D7-D139FF6D8046}"/>
    <pc:docChg chg="undo modSld">
      <pc:chgData name="Fernanda Erpel" userId="29d1baa5783f2a02" providerId="LiveId" clId="{5888FCE2-01D7-435A-81D7-D139FF6D8046}" dt="2020-09-03T20:45:03.810" v="6"/>
      <pc:docMkLst>
        <pc:docMk/>
      </pc:docMkLst>
      <pc:sldChg chg="modSp">
        <pc:chgData name="Fernanda Erpel" userId="29d1baa5783f2a02" providerId="LiveId" clId="{5888FCE2-01D7-435A-81D7-D139FF6D8046}" dt="2020-09-03T20:45:03.810" v="6"/>
        <pc:sldMkLst>
          <pc:docMk/>
          <pc:sldMk cId="1410122683" sldId="256"/>
        </pc:sldMkLst>
        <pc:graphicFrameChg chg="mod">
          <ac:chgData name="Fernanda Erpel" userId="29d1baa5783f2a02" providerId="LiveId" clId="{5888FCE2-01D7-435A-81D7-D139FF6D8046}" dt="2020-09-03T20:45:03.810" v="6"/>
          <ac:graphicFrameMkLst>
            <pc:docMk/>
            <pc:sldMk cId="1410122683" sldId="256"/>
            <ac:graphicFrameMk id="2" creationId="{52175ED7-E29C-4E8A-8A80-BF7E1194163E}"/>
          </ac:graphicFrameMkLst>
        </pc:graphicFrameChg>
      </pc:sldChg>
    </pc:docChg>
  </pc:docChgLst>
  <pc:docChgLst>
    <pc:chgData name="Fernanda Erpel" userId="29d1baa5783f2a02" providerId="LiveId" clId="{F8AFB064-21A0-4473-AFA7-74D8C096FACB}"/>
    <pc:docChg chg="modSld">
      <pc:chgData name="Fernanda Erpel" userId="29d1baa5783f2a02" providerId="LiveId" clId="{F8AFB064-21A0-4473-AFA7-74D8C096FACB}" dt="2021-03-19T19:43:36.766" v="6" actId="20577"/>
      <pc:docMkLst>
        <pc:docMk/>
      </pc:docMkLst>
      <pc:sldChg chg="modSp mod">
        <pc:chgData name="Fernanda Erpel" userId="29d1baa5783f2a02" providerId="LiveId" clId="{F8AFB064-21A0-4473-AFA7-74D8C096FACB}" dt="2021-03-19T19:43:36.766" v="6" actId="20577"/>
        <pc:sldMkLst>
          <pc:docMk/>
          <pc:sldMk cId="1410122683" sldId="256"/>
        </pc:sldMkLst>
        <pc:spChg chg="mod">
          <ac:chgData name="Fernanda Erpel" userId="29d1baa5783f2a02" providerId="LiveId" clId="{F8AFB064-21A0-4473-AFA7-74D8C096FACB}" dt="2021-03-19T19:43:36.766" v="6" actId="20577"/>
          <ac:spMkLst>
            <pc:docMk/>
            <pc:sldMk cId="1410122683" sldId="256"/>
            <ac:spMk id="5" creationId="{7C3F3686-FE3A-437E-A48B-2E1356E4ADA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652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7947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3139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8859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632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1014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8606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222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2957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1622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194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1C5A8B-3507-44E3-86B2-AD53F6F8107C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D98AE-6192-49CF-B951-5EA5D0C4A66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50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7C3F3686-FE3A-437E-A48B-2E1356E4ADAC}"/>
              </a:ext>
            </a:extLst>
          </p:cNvPr>
          <p:cNvSpPr txBox="1"/>
          <p:nvPr/>
        </p:nvSpPr>
        <p:spPr>
          <a:xfrm>
            <a:off x="379084" y="673703"/>
            <a:ext cx="609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Table S3. </a:t>
            </a:r>
            <a:r>
              <a:rPr lang="en-US" sz="900" dirty="0">
                <a:latin typeface="Palatino Linotype" panose="02040502050505030304" pitchFamily="18" charset="0"/>
              </a:rPr>
              <a:t>Three-way ANOVA for the effects of the specie, alga part, and collection zone on the PHLE extracts ORAC values, expressed as dry seaweed. Statistically significant effects (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≤</a:t>
            </a:r>
            <a:r>
              <a:rPr lang="en-US" sz="900" dirty="0">
                <a:latin typeface="Palatino Linotype" panose="02040502050505030304" pitchFamily="18" charset="0"/>
              </a:rPr>
              <a:t>0.05) are shown in bold. 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52175ED7-E29C-4E8A-8A80-BF7E119416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3258606"/>
              </p:ext>
            </p:extLst>
          </p:nvPr>
        </p:nvGraphicFramePr>
        <p:xfrm>
          <a:off x="1145223" y="1111885"/>
          <a:ext cx="4762500" cy="220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762323" imgH="2209839" progId="Excel.Sheet.12">
                  <p:embed/>
                </p:oleObj>
              </mc:Choice>
              <mc:Fallback>
                <p:oleObj name="Worksheet" r:id="rId2" imgW="4762323" imgH="2209839" progId="Excel.Sheet.12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52175ED7-E29C-4E8A-8A80-BF7E119416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45223" y="1111885"/>
                        <a:ext cx="4762500" cy="220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101226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43</Words>
  <Application>Microsoft Office PowerPoint</Application>
  <PresentationFormat>Carta (216 x 279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Symbol</vt:lpstr>
      <vt:lpstr>Tema de Office</vt:lpstr>
      <vt:lpstr>Hoja de cálculo de Microsoft Excel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Erpel</dc:creator>
  <cp:lastModifiedBy>Fernanda Erpel</cp:lastModifiedBy>
  <cp:revision>3</cp:revision>
  <dcterms:created xsi:type="dcterms:W3CDTF">2020-08-06T00:17:35Z</dcterms:created>
  <dcterms:modified xsi:type="dcterms:W3CDTF">2021-06-02T17:46:08Z</dcterms:modified>
</cp:coreProperties>
</file>